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43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5736" y="404664"/>
            <a:ext cx="4320480" cy="34243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7504" y="4108137"/>
            <a:ext cx="8928992" cy="1985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.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fertility of four autotetraploid rice hybrids. “**” indicate significant differences in three hybrids (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449-4x×E1-4x, T449-4x×E24-4x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 T449-4x×E245-4x) compared to control hybrid (E1-4x×E24-4x). E1-4x×E24-4x represent autotetraploid rice hybrid harboring pervasive interactions 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erility loci. T449-4x×E1-4x and T449-4x×E24-4x have no-interaction 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i, but interaction exists at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us. T449-4x×E245-4x has no-interaction 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ollen sterility loci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2824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3</cp:revision>
  <dcterms:modified xsi:type="dcterms:W3CDTF">2017-10-19T07:59:15Z</dcterms:modified>
</cp:coreProperties>
</file>